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091F4F-46FC-4BC5-B90E-195CF28C3D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C5C8B3-F2B5-40E8-A017-1B628C75AC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B551D-B7E1-4191-8B68-6A59736FF5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874DF-6A7B-4F0F-ADB0-8442ECEB05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60A0AF-0222-44BC-AC86-2A6EBE5E09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F9013-6B53-43CE-8B7F-9E22CA5C6C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5414D-97A2-4BF9-B6EC-BD73A8751E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3A794-E5A6-4298-B2C5-95A2A0AD53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8610D-6A6C-450E-AADD-D7CE88E6EA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F3839A-CE89-4F0C-8404-A54DCE4C9D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236E6-5B79-48B7-A73D-753BA95862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980521-B45E-430F-A4E3-4F56A4DE64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18FC84-DFBF-43D8-A215-D814399E079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/>
          <p:cNvSpPr/>
          <p:nvPr/>
        </p:nvSpPr>
        <p:spPr>
          <a:xfrm>
            <a:off x="1862280" y="2965320"/>
            <a:ext cx="142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ent. Loc.- Marker Loc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2"/>
          <p:cNvSpPr/>
          <p:nvPr/>
        </p:nvSpPr>
        <p:spPr>
          <a:xfrm>
            <a:off x="3224160" y="2965320"/>
            <a:ext cx="187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arker Loc.- Centromere Loc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5"/>
          <p:cNvSpPr/>
          <p:nvPr/>
        </p:nvSpPr>
        <p:spPr>
          <a:xfrm>
            <a:off x="2724120" y="1930320"/>
            <a:ext cx="99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entromer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6"/>
          <p:cNvSpPr/>
          <p:nvPr/>
        </p:nvSpPr>
        <p:spPr>
          <a:xfrm>
            <a:off x="1511280" y="1109520"/>
            <a:ext cx="395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aize B73 RefGen_v2 Chromosome 1: 300.8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Left Brace 29"/>
          <p:cNvSpPr/>
          <p:nvPr/>
        </p:nvSpPr>
        <p:spPr>
          <a:xfrm rot="5400000">
            <a:off x="3388320" y="-1738800"/>
            <a:ext cx="196920" cy="6433920"/>
          </a:xfrm>
          <a:custGeom>
            <a:avLst/>
            <a:gdLst>
              <a:gd name="textAreaLeft" fmla="*/ 126000 w 196920"/>
              <a:gd name="textAreaRight" fmla="*/ 197280 w 196920"/>
              <a:gd name="textAreaTop" fmla="*/ 5040 h 6433920"/>
              <a:gd name="textAreaBottom" fmla="*/ 6428880 h 6433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28"/>
                  <a:pt x="10800" y="55"/>
                </a:cubicBezTo>
                <a:lnTo>
                  <a:pt x="10800" y="10745"/>
                </a:lnTo>
                <a:cubicBezTo>
                  <a:pt x="10800" y="10773"/>
                  <a:pt x="5400" y="10800"/>
                  <a:pt x="0" y="10800"/>
                </a:cubicBezTo>
                <a:cubicBezTo>
                  <a:pt x="5400" y="10800"/>
                  <a:pt x="10800" y="10828"/>
                  <a:pt x="10800" y="10855"/>
                </a:cubicBezTo>
                <a:lnTo>
                  <a:pt x="10800" y="21545"/>
                </a:lnTo>
                <a:cubicBezTo>
                  <a:pt x="10800" y="21573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eft Brace 30"/>
          <p:cNvSpPr/>
          <p:nvPr/>
        </p:nvSpPr>
        <p:spPr>
          <a:xfrm rot="5400000">
            <a:off x="1608480" y="445320"/>
            <a:ext cx="210960" cy="2889000"/>
          </a:xfrm>
          <a:custGeom>
            <a:avLst/>
            <a:gdLst>
              <a:gd name="textAreaLeft" fmla="*/ 135000 w 210960"/>
              <a:gd name="textAreaRight" fmla="*/ 211320 w 210960"/>
              <a:gd name="textAreaTop" fmla="*/ 5400 h 2889000"/>
              <a:gd name="textAreaBottom" fmla="*/ 2883600 h 2889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66"/>
                  <a:pt x="10800" y="132"/>
                </a:cubicBezTo>
                <a:lnTo>
                  <a:pt x="10800" y="10668"/>
                </a:lnTo>
                <a:cubicBezTo>
                  <a:pt x="10800" y="10734"/>
                  <a:pt x="5400" y="10800"/>
                  <a:pt x="0" y="10800"/>
                </a:cubicBezTo>
                <a:cubicBezTo>
                  <a:pt x="5400" y="10800"/>
                  <a:pt x="10800" y="10866"/>
                  <a:pt x="10800" y="10932"/>
                </a:cubicBezTo>
                <a:lnTo>
                  <a:pt x="10800" y="21468"/>
                </a:lnTo>
                <a:cubicBezTo>
                  <a:pt x="10800" y="21534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eft Brace 31"/>
          <p:cNvSpPr/>
          <p:nvPr/>
        </p:nvSpPr>
        <p:spPr>
          <a:xfrm rot="5400000">
            <a:off x="4840920" y="116640"/>
            <a:ext cx="214200" cy="3549600"/>
          </a:xfrm>
          <a:custGeom>
            <a:avLst/>
            <a:gdLst>
              <a:gd name="textAreaLeft" fmla="*/ 136800 w 214200"/>
              <a:gd name="textAreaRight" fmla="*/ 214560 w 214200"/>
              <a:gd name="textAreaTop" fmla="*/ 5400 h 3549600"/>
              <a:gd name="textAreaBottom" fmla="*/ 3544200 h 35496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55"/>
                  <a:pt x="10800" y="109"/>
                </a:cubicBezTo>
                <a:lnTo>
                  <a:pt x="10800" y="10691"/>
                </a:lnTo>
                <a:cubicBezTo>
                  <a:pt x="10800" y="10746"/>
                  <a:pt x="5400" y="10800"/>
                  <a:pt x="0" y="10800"/>
                </a:cubicBezTo>
                <a:cubicBezTo>
                  <a:pt x="5400" y="10800"/>
                  <a:pt x="10800" y="10855"/>
                  <a:pt x="10800" y="10909"/>
                </a:cubicBezTo>
                <a:lnTo>
                  <a:pt x="10800" y="21491"/>
                </a:lnTo>
                <a:cubicBezTo>
                  <a:pt x="10800" y="21546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2"/>
          <p:cNvSpPr/>
          <p:nvPr/>
        </p:nvSpPr>
        <p:spPr>
          <a:xfrm>
            <a:off x="1206720" y="1531800"/>
            <a:ext cx="1034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S= 134.7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3"/>
          <p:cNvSpPr/>
          <p:nvPr/>
        </p:nvSpPr>
        <p:spPr>
          <a:xfrm>
            <a:off x="4423680" y="1531800"/>
            <a:ext cx="102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L= 166.1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8"/>
          <p:cNvSpPr/>
          <p:nvPr/>
        </p:nvSpPr>
        <p:spPr>
          <a:xfrm>
            <a:off x="1786320" y="2708280"/>
            <a:ext cx="69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2.9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ight Bracket 39"/>
          <p:cNvSpPr/>
          <p:nvPr/>
        </p:nvSpPr>
        <p:spPr>
          <a:xfrm rot="5400000">
            <a:off x="2583000" y="2423160"/>
            <a:ext cx="46080" cy="1104840"/>
          </a:xfrm>
          <a:custGeom>
            <a:avLst/>
            <a:gdLst>
              <a:gd name="textAreaLeft" fmla="*/ 0 w 46080"/>
              <a:gd name="textAreaRight" fmla="*/ 32400 w 46080"/>
              <a:gd name="textAreaTop" fmla="*/ 1800 h 1104840"/>
              <a:gd name="textAreaBottom" fmla="*/ 1103040 h 1104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38"/>
                  <a:pt x="21600" y="75"/>
                </a:cubicBezTo>
                <a:lnTo>
                  <a:pt x="21600" y="21525"/>
                </a:lnTo>
                <a:cubicBezTo>
                  <a:pt x="21600" y="21563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1"/>
          <p:cNvSpPr/>
          <p:nvPr/>
        </p:nvSpPr>
        <p:spPr>
          <a:xfrm>
            <a:off x="2117880" y="3451320"/>
            <a:ext cx="2962080" cy="62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Distance from Centromer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Calibri"/>
              </a:rPr>
              <a:t>X  100  = RMP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otal Arm Lengt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ight Bracket 44"/>
          <p:cNvSpPr/>
          <p:nvPr/>
        </p:nvSpPr>
        <p:spPr>
          <a:xfrm rot="5400000">
            <a:off x="4138200" y="2004840"/>
            <a:ext cx="46080" cy="1941480"/>
          </a:xfrm>
          <a:custGeom>
            <a:avLst/>
            <a:gdLst>
              <a:gd name="textAreaLeft" fmla="*/ 0 w 46080"/>
              <a:gd name="textAreaRight" fmla="*/ 32400 w 46080"/>
              <a:gd name="textAreaTop" fmla="*/ 1800 h 1941480"/>
              <a:gd name="textAreaBottom" fmla="*/ 1939680 h 1941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21"/>
                  <a:pt x="21600" y="42"/>
                </a:cubicBezTo>
                <a:lnTo>
                  <a:pt x="21600" y="21558"/>
                </a:lnTo>
                <a:cubicBezTo>
                  <a:pt x="21600" y="21579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45"/>
          <p:cNvSpPr/>
          <p:nvPr/>
        </p:nvSpPr>
        <p:spPr>
          <a:xfrm>
            <a:off x="4793040" y="270828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27.8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37" descr="Chr1.jpg"/>
          <p:cNvPicPr/>
          <p:nvPr/>
        </p:nvPicPr>
        <p:blipFill>
          <a:blip r:embed="rId1"/>
          <a:stretch/>
        </p:blipFill>
        <p:spPr>
          <a:xfrm>
            <a:off x="223920" y="2209680"/>
            <a:ext cx="6502320" cy="479520"/>
          </a:xfrm>
          <a:prstGeom prst="rect">
            <a:avLst/>
          </a:prstGeom>
          <a:ln w="0">
            <a:noFill/>
          </a:ln>
        </p:spPr>
      </p:pic>
      <p:sp>
        <p:nvSpPr>
          <p:cNvPr id="56" name="TextBox 55"/>
          <p:cNvSpPr/>
          <p:nvPr/>
        </p:nvSpPr>
        <p:spPr>
          <a:xfrm>
            <a:off x="1832400" y="1930320"/>
            <a:ext cx="46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su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56"/>
          <p:cNvSpPr/>
          <p:nvPr/>
        </p:nvSpPr>
        <p:spPr>
          <a:xfrm>
            <a:off x="4745880" y="1930320"/>
            <a:ext cx="75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mc128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7"/>
          <p:cNvSpPr/>
          <p:nvPr/>
        </p:nvSpPr>
        <p:spPr>
          <a:xfrm>
            <a:off x="134280" y="2690640"/>
            <a:ext cx="117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Genomic Locus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8"/>
          <p:cNvSpPr/>
          <p:nvPr/>
        </p:nvSpPr>
        <p:spPr>
          <a:xfrm>
            <a:off x="135720" y="2951280"/>
            <a:ext cx="147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Distance from Cent.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5"/>
          <p:cNvSpPr/>
          <p:nvPr/>
        </p:nvSpPr>
        <p:spPr>
          <a:xfrm>
            <a:off x="134280" y="1531800"/>
            <a:ext cx="973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rm Length: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6"/>
          <p:cNvSpPr/>
          <p:nvPr/>
        </p:nvSpPr>
        <p:spPr>
          <a:xfrm>
            <a:off x="259920" y="94932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66"/>
          <p:cNvSpPr/>
          <p:nvPr/>
        </p:nvSpPr>
        <p:spPr>
          <a:xfrm>
            <a:off x="1979640" y="8350200"/>
            <a:ext cx="2898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81040"/>
                <a:tab algn="l" pos="1162080"/>
                <a:tab algn="l" pos="1743120"/>
                <a:tab algn="l" pos="2324160"/>
                <a:tab algn="l" pos="2905200"/>
                <a:tab algn="l" pos="3486240"/>
                <a:tab algn="l" pos="4067280"/>
                <a:tab algn="l" pos="4648320"/>
                <a:tab algn="l" pos="5229360"/>
                <a:tab algn="l" pos="5810400"/>
                <a:tab algn="l" pos="6391440"/>
                <a:tab algn="l" pos="6972480"/>
                <a:tab algn="l" pos="7553160"/>
                <a:tab algn="l" pos="8134200"/>
                <a:tab algn="l" pos="8715240"/>
                <a:tab algn="l" pos="9296280"/>
                <a:tab algn="l" pos="9877320"/>
                <a:tab algn="l" pos="10458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. Figueroa and Bas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4"/>
          <p:cNvSpPr/>
          <p:nvPr/>
        </p:nvSpPr>
        <p:spPr>
          <a:xfrm>
            <a:off x="3170160" y="2147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51"/>
          <p:cNvSpPr/>
          <p:nvPr/>
        </p:nvSpPr>
        <p:spPr>
          <a:xfrm>
            <a:off x="2041560" y="2147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Straight Connector 52"/>
          <p:cNvSpPr/>
          <p:nvPr/>
        </p:nvSpPr>
        <p:spPr>
          <a:xfrm>
            <a:off x="5129280" y="2147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Straight Connector 53"/>
          <p:cNvSpPr/>
          <p:nvPr/>
        </p:nvSpPr>
        <p:spPr>
          <a:xfrm>
            <a:off x="2041560" y="2606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Straight Connector 54"/>
          <p:cNvSpPr/>
          <p:nvPr/>
        </p:nvSpPr>
        <p:spPr>
          <a:xfrm>
            <a:off x="5129280" y="2606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7"/>
          <p:cNvSpPr/>
          <p:nvPr/>
        </p:nvSpPr>
        <p:spPr>
          <a:xfrm>
            <a:off x="1060200" y="4173480"/>
            <a:ext cx="1965240" cy="58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134.7 – 82.9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X 100 = 38 = 1S.3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34.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7"/>
          <p:cNvSpPr/>
          <p:nvPr/>
        </p:nvSpPr>
        <p:spPr>
          <a:xfrm>
            <a:off x="4074840" y="4173480"/>
            <a:ext cx="2103840" cy="58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227.8 - 134.7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Calibri"/>
              </a:rPr>
              <a:t>X 100 = 56% = 1L.5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66.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58"/>
          <p:cNvSpPr/>
          <p:nvPr/>
        </p:nvSpPr>
        <p:spPr>
          <a:xfrm>
            <a:off x="2041560" y="3220920"/>
            <a:ext cx="0" cy="941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59"/>
          <p:cNvSpPr/>
          <p:nvPr/>
        </p:nvSpPr>
        <p:spPr>
          <a:xfrm flipH="1">
            <a:off x="5128920" y="3220920"/>
            <a:ext cx="6120" cy="9414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"/>
          <p:cNvSpPr/>
          <p:nvPr/>
        </p:nvSpPr>
        <p:spPr>
          <a:xfrm>
            <a:off x="2856240" y="270828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34.7 M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34"/>
          <p:cNvSpPr/>
          <p:nvPr/>
        </p:nvSpPr>
        <p:spPr>
          <a:xfrm>
            <a:off x="3170160" y="2606760"/>
            <a:ext cx="0" cy="1508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7T18:01:01Z</dcterms:created>
  <dc:creator>Debbie Figueroa</dc:creator>
  <dc:description/>
  <cp:keywords/>
  <dc:language>en-US</dc:language>
  <cp:lastModifiedBy>Hank Bass</cp:lastModifiedBy>
  <dcterms:modified xsi:type="dcterms:W3CDTF">2012-02-13T20:10:12Z</dcterms:modified>
  <cp:revision>34</cp:revision>
  <dc:subject/>
  <dc:title>Slide 1</dc:title>
</cp:coreProperties>
</file>